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41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 descr="Text, letter&#10;&#10;Description automatically generated">
            <a:extLst>
              <a:ext uri="{FF2B5EF4-FFF2-40B4-BE49-F238E27FC236}">
                <a16:creationId xmlns:a16="http://schemas.microsoft.com/office/drawing/2014/main" id="{842C214F-24ED-4BDB-E801-2347787203B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7" t="34305" r="19577" b="48129"/>
          <a:stretch/>
        </p:blipFill>
        <p:spPr>
          <a:xfrm>
            <a:off x="1297036" y="4486349"/>
            <a:ext cx="2341325" cy="61054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39BA912-213F-CE11-7D2C-20F5CC0FAB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059" t="34776" r="25969" b="42074"/>
          <a:stretch/>
        </p:blipFill>
        <p:spPr>
          <a:xfrm>
            <a:off x="1289690" y="2880129"/>
            <a:ext cx="2348670" cy="14557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DB3115C-B416-50D3-7509-CC665446E74A}"/>
              </a:ext>
            </a:extLst>
          </p:cNvPr>
          <p:cNvSpPr txBox="1"/>
          <p:nvPr/>
        </p:nvSpPr>
        <p:spPr>
          <a:xfrm>
            <a:off x="805527" y="3240997"/>
            <a:ext cx="441146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 err="1"/>
              <a:t>Myc</a:t>
            </a:r>
            <a:endParaRPr lang="en-US" sz="1148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2D8836-0499-3F98-65B7-2FE172B9EB89}"/>
              </a:ext>
            </a:extLst>
          </p:cNvPr>
          <p:cNvSpPr txBox="1"/>
          <p:nvPr/>
        </p:nvSpPr>
        <p:spPr>
          <a:xfrm>
            <a:off x="691668" y="4717820"/>
            <a:ext cx="662361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Vinc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4CBDF7-AED0-89B2-1A5B-3B254F56747C}"/>
              </a:ext>
            </a:extLst>
          </p:cNvPr>
          <p:cNvSpPr txBox="1"/>
          <p:nvPr/>
        </p:nvSpPr>
        <p:spPr>
          <a:xfrm>
            <a:off x="608324" y="2585983"/>
            <a:ext cx="936475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0058-F4 [µM]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B5030B-4BED-289E-405E-8236E46225DC}"/>
              </a:ext>
            </a:extLst>
          </p:cNvPr>
          <p:cNvSpPr txBox="1"/>
          <p:nvPr/>
        </p:nvSpPr>
        <p:spPr>
          <a:xfrm>
            <a:off x="706828" y="1857299"/>
            <a:ext cx="1334020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Extended Figure 9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68A9305-5515-D3DC-D418-B01D77F43CA6}"/>
              </a:ext>
            </a:extLst>
          </p:cNvPr>
          <p:cNvSpPr txBox="1"/>
          <p:nvPr/>
        </p:nvSpPr>
        <p:spPr>
          <a:xfrm>
            <a:off x="2366894" y="1857299"/>
            <a:ext cx="1340432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/>
              <a:t>Extended Figure 9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A7467A-E1DD-DB0E-AC7F-A69C26B73E4F}"/>
              </a:ext>
            </a:extLst>
          </p:cNvPr>
          <p:cNvSpPr txBox="1"/>
          <p:nvPr/>
        </p:nvSpPr>
        <p:spPr>
          <a:xfrm rot="16200000">
            <a:off x="1733294" y="2401142"/>
            <a:ext cx="377026" cy="5045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5E294F-3C98-0D8C-5382-30F2B0753CEA}"/>
              </a:ext>
            </a:extLst>
          </p:cNvPr>
          <p:cNvSpPr txBox="1"/>
          <p:nvPr/>
        </p:nvSpPr>
        <p:spPr>
          <a:xfrm>
            <a:off x="1591630" y="2595710"/>
            <a:ext cx="29146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8229BF-CB7E-7A95-01C6-315D0C0B0995}"/>
              </a:ext>
            </a:extLst>
          </p:cNvPr>
          <p:cNvSpPr txBox="1"/>
          <p:nvPr/>
        </p:nvSpPr>
        <p:spPr>
          <a:xfrm>
            <a:off x="2815365" y="2585035"/>
            <a:ext cx="95571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Fedratinib [µM]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37B2BE-9E57-B656-ABB0-0149E7084438}"/>
              </a:ext>
            </a:extLst>
          </p:cNvPr>
          <p:cNvSpPr txBox="1"/>
          <p:nvPr/>
        </p:nvSpPr>
        <p:spPr>
          <a:xfrm rot="16200000">
            <a:off x="2341849" y="2416982"/>
            <a:ext cx="344966" cy="5045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6E0AE15-F6D7-E034-C2B2-9DDC558CB284}"/>
              </a:ext>
            </a:extLst>
          </p:cNvPr>
          <p:cNvSpPr txBox="1"/>
          <p:nvPr/>
        </p:nvSpPr>
        <p:spPr>
          <a:xfrm>
            <a:off x="2184156" y="2585620"/>
            <a:ext cx="29146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-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2F7363D-5255-D0F8-0579-193422C29953}"/>
              </a:ext>
            </a:extLst>
          </p:cNvPr>
          <p:cNvCxnSpPr>
            <a:cxnSpLocks/>
          </p:cNvCxnSpPr>
          <p:nvPr/>
        </p:nvCxnSpPr>
        <p:spPr>
          <a:xfrm>
            <a:off x="2184156" y="2791848"/>
            <a:ext cx="13696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AC9107C-00CC-D943-8078-BDD8072D2610}"/>
              </a:ext>
            </a:extLst>
          </p:cNvPr>
          <p:cNvCxnSpPr>
            <a:cxnSpLocks/>
          </p:cNvCxnSpPr>
          <p:nvPr/>
        </p:nvCxnSpPr>
        <p:spPr>
          <a:xfrm>
            <a:off x="691667" y="2788341"/>
            <a:ext cx="13696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52F2394F-DD6C-6126-BE9B-C7EB08712E28}"/>
              </a:ext>
            </a:extLst>
          </p:cNvPr>
          <p:cNvSpPr/>
          <p:nvPr/>
        </p:nvSpPr>
        <p:spPr>
          <a:xfrm rot="5738363">
            <a:off x="1774368" y="2222709"/>
            <a:ext cx="92761" cy="473057"/>
          </a:xfrm>
          <a:custGeom>
            <a:avLst/>
            <a:gdLst>
              <a:gd name="connsiteX0" fmla="*/ 0 w 90093"/>
              <a:gd name="connsiteY0" fmla="*/ 461307 h 461307"/>
              <a:gd name="connsiteX1" fmla="*/ 45047 w 90093"/>
              <a:gd name="connsiteY1" fmla="*/ 0 h 461307"/>
              <a:gd name="connsiteX2" fmla="*/ 90093 w 90093"/>
              <a:gd name="connsiteY2" fmla="*/ 461307 h 461307"/>
              <a:gd name="connsiteX3" fmla="*/ 0 w 90093"/>
              <a:gd name="connsiteY3" fmla="*/ 461307 h 461307"/>
              <a:gd name="connsiteX0" fmla="*/ 0 w 96553"/>
              <a:gd name="connsiteY0" fmla="*/ 473431 h 473431"/>
              <a:gd name="connsiteX1" fmla="*/ 51507 w 96553"/>
              <a:gd name="connsiteY1" fmla="*/ 0 h 473431"/>
              <a:gd name="connsiteX2" fmla="*/ 96553 w 96553"/>
              <a:gd name="connsiteY2" fmla="*/ 461307 h 473431"/>
              <a:gd name="connsiteX3" fmla="*/ 0 w 96553"/>
              <a:gd name="connsiteY3" fmla="*/ 473431 h 473431"/>
              <a:gd name="connsiteX0" fmla="*/ 0 w 92761"/>
              <a:gd name="connsiteY0" fmla="*/ 473057 h 473057"/>
              <a:gd name="connsiteX1" fmla="*/ 47715 w 92761"/>
              <a:gd name="connsiteY1" fmla="*/ 0 h 473057"/>
              <a:gd name="connsiteX2" fmla="*/ 92761 w 92761"/>
              <a:gd name="connsiteY2" fmla="*/ 461307 h 473057"/>
              <a:gd name="connsiteX3" fmla="*/ 0 w 92761"/>
              <a:gd name="connsiteY3" fmla="*/ 473057 h 4730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2761" h="473057">
                <a:moveTo>
                  <a:pt x="0" y="473057"/>
                </a:moveTo>
                <a:lnTo>
                  <a:pt x="47715" y="0"/>
                </a:lnTo>
                <a:lnTo>
                  <a:pt x="92761" y="461307"/>
                </a:lnTo>
                <a:lnTo>
                  <a:pt x="0" y="473057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 dirty="0">
              <a:solidFill>
                <a:schemeClr val="tx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765DAA0-3F8A-7F86-2C3C-868A834068C7}"/>
              </a:ext>
            </a:extLst>
          </p:cNvPr>
          <p:cNvSpPr txBox="1"/>
          <p:nvPr/>
        </p:nvSpPr>
        <p:spPr>
          <a:xfrm>
            <a:off x="3810824" y="2584085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8BD3F9B-E5F4-64E5-9D09-AB303B1170D2}"/>
              </a:ext>
            </a:extLst>
          </p:cNvPr>
          <p:cNvSpPr txBox="1"/>
          <p:nvPr/>
        </p:nvSpPr>
        <p:spPr>
          <a:xfrm>
            <a:off x="3882359" y="3233066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BC502E4-86C9-B33C-8797-E4E839B85B80}"/>
              </a:ext>
            </a:extLst>
          </p:cNvPr>
          <p:cNvSpPr txBox="1"/>
          <p:nvPr/>
        </p:nvSpPr>
        <p:spPr>
          <a:xfrm>
            <a:off x="3857293" y="4693516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4D3F66B-2AF3-5367-E96D-8AC3D75C04DF}"/>
              </a:ext>
            </a:extLst>
          </p:cNvPr>
          <p:cNvSpPr/>
          <p:nvPr/>
        </p:nvSpPr>
        <p:spPr>
          <a:xfrm>
            <a:off x="1567925" y="3275426"/>
            <a:ext cx="587811" cy="190916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BB80201-8EC6-2B25-F21D-7DD197C12DF7}"/>
              </a:ext>
            </a:extLst>
          </p:cNvPr>
          <p:cNvSpPr/>
          <p:nvPr/>
        </p:nvSpPr>
        <p:spPr>
          <a:xfrm>
            <a:off x="1567925" y="4679970"/>
            <a:ext cx="536700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F7A21A6-DCD3-B1D4-7E0C-62125B887D11}"/>
              </a:ext>
            </a:extLst>
          </p:cNvPr>
          <p:cNvSpPr/>
          <p:nvPr/>
        </p:nvSpPr>
        <p:spPr>
          <a:xfrm>
            <a:off x="2130336" y="4622269"/>
            <a:ext cx="536700" cy="37939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C8A595F-22B2-D90C-292B-859C6917AE63}"/>
              </a:ext>
            </a:extLst>
          </p:cNvPr>
          <p:cNvSpPr/>
          <p:nvPr/>
        </p:nvSpPr>
        <p:spPr>
          <a:xfrm>
            <a:off x="2145366" y="3210644"/>
            <a:ext cx="536700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15" name="Isosceles Triangle 20">
            <a:extLst>
              <a:ext uri="{FF2B5EF4-FFF2-40B4-BE49-F238E27FC236}">
                <a16:creationId xmlns:a16="http://schemas.microsoft.com/office/drawing/2014/main" id="{073863C9-6070-CD8A-F85D-CF7C216A9DF2}"/>
              </a:ext>
            </a:extLst>
          </p:cNvPr>
          <p:cNvSpPr/>
          <p:nvPr/>
        </p:nvSpPr>
        <p:spPr>
          <a:xfrm rot="5738363">
            <a:off x="2367649" y="2220270"/>
            <a:ext cx="92761" cy="473057"/>
          </a:xfrm>
          <a:custGeom>
            <a:avLst/>
            <a:gdLst>
              <a:gd name="connsiteX0" fmla="*/ 0 w 90093"/>
              <a:gd name="connsiteY0" fmla="*/ 461307 h 461307"/>
              <a:gd name="connsiteX1" fmla="*/ 45047 w 90093"/>
              <a:gd name="connsiteY1" fmla="*/ 0 h 461307"/>
              <a:gd name="connsiteX2" fmla="*/ 90093 w 90093"/>
              <a:gd name="connsiteY2" fmla="*/ 461307 h 461307"/>
              <a:gd name="connsiteX3" fmla="*/ 0 w 90093"/>
              <a:gd name="connsiteY3" fmla="*/ 461307 h 461307"/>
              <a:gd name="connsiteX0" fmla="*/ 0 w 96553"/>
              <a:gd name="connsiteY0" fmla="*/ 473431 h 473431"/>
              <a:gd name="connsiteX1" fmla="*/ 51507 w 96553"/>
              <a:gd name="connsiteY1" fmla="*/ 0 h 473431"/>
              <a:gd name="connsiteX2" fmla="*/ 96553 w 96553"/>
              <a:gd name="connsiteY2" fmla="*/ 461307 h 473431"/>
              <a:gd name="connsiteX3" fmla="*/ 0 w 96553"/>
              <a:gd name="connsiteY3" fmla="*/ 473431 h 473431"/>
              <a:gd name="connsiteX0" fmla="*/ 0 w 92761"/>
              <a:gd name="connsiteY0" fmla="*/ 473057 h 473057"/>
              <a:gd name="connsiteX1" fmla="*/ 47715 w 92761"/>
              <a:gd name="connsiteY1" fmla="*/ 0 h 473057"/>
              <a:gd name="connsiteX2" fmla="*/ 92761 w 92761"/>
              <a:gd name="connsiteY2" fmla="*/ 461307 h 473057"/>
              <a:gd name="connsiteX3" fmla="*/ 0 w 92761"/>
              <a:gd name="connsiteY3" fmla="*/ 473057 h 47305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2761" h="473057">
                <a:moveTo>
                  <a:pt x="0" y="473057"/>
                </a:moveTo>
                <a:lnTo>
                  <a:pt x="47715" y="0"/>
                </a:lnTo>
                <a:lnTo>
                  <a:pt x="92761" y="461307"/>
                </a:lnTo>
                <a:lnTo>
                  <a:pt x="0" y="473057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 dirty="0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DF8646A-7CF6-B230-6E87-E3CE51CF0C32}"/>
              </a:ext>
            </a:extLst>
          </p:cNvPr>
          <p:cNvSpPr txBox="1"/>
          <p:nvPr/>
        </p:nvSpPr>
        <p:spPr>
          <a:xfrm>
            <a:off x="209904" y="166613"/>
            <a:ext cx="6766560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Extended Data Figure 9a,b</a:t>
            </a:r>
          </a:p>
        </p:txBody>
      </p:sp>
    </p:spTree>
    <p:extLst>
      <p:ext uri="{BB962C8B-B14F-4D97-AF65-F5344CB8AC3E}">
        <p14:creationId xmlns:p14="http://schemas.microsoft.com/office/powerpoint/2010/main" val="2904604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44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6:12Z</dcterms:modified>
</cp:coreProperties>
</file>